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58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megowda" initials="H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34" autoAdjust="0"/>
  </p:normalViewPr>
  <p:slideViewPr>
    <p:cSldViewPr snapToGrid="0">
      <p:cViewPr>
        <p:scale>
          <a:sx n="75" d="100"/>
          <a:sy n="75" d="100"/>
        </p:scale>
        <p:origin x="516" y="-360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3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12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8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6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83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01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98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52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346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0060" y="12366171"/>
            <a:ext cx="110163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Metabolis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verview map showing differences in transcript levels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combine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ought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irus infecte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. thaliana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lants.  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figure is generated using MapMan software and is based on the data provided by Prasch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onnewal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2013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ant Physi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162(4),1849-66. The data (fold change expression values) were loaded into the MapMan Image Annotat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du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generate the metabolism overview map. On the logarithmic color scale ranging from 4.5 to 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.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reen 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 red represen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wn-regula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cripts.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/>
          <a:srcRect r="24139"/>
          <a:stretch/>
        </p:blipFill>
        <p:spPr>
          <a:xfrm>
            <a:off x="742446" y="3339489"/>
            <a:ext cx="10753957" cy="7914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8841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5.PPTX</TitleName>
    <StageName xmlns="ad5e6ac6-7e28-44ff-b599-4b096ee3745e" xsi:nil="true"/>
    <DocumentType xmlns="ad5e6ac6-7e28-44ff-b599-4b096ee3745e">Presentation</DocumentType>
    <DocumentId xmlns="ad5e6ac6-7e28-44ff-b599-4b096ee3745e">Presentation 5.PPTX</DocumentId>
  </documentManagement>
</p:properties>
</file>

<file path=customXml/itemProps1.xml><?xml version="1.0" encoding="utf-8"?>
<ds:datastoreItem xmlns:ds="http://schemas.openxmlformats.org/officeDocument/2006/customXml" ds:itemID="{5570F364-BC0C-4601-A4A0-13DED5B9E1C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5e6ac6-7e28-44ff-b599-4b096ee3745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45EB3D56-E3E5-4C0C-9EA8-520F55AD74F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176FB2C-591B-4017-96BF-B2880CF18D60}">
  <ds:schemaRefs>
    <ds:schemaRef ds:uri="http://purl.org/dc/elements/1.1/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purl.org/dc/dcmitype/"/>
    <ds:schemaRef ds:uri="ad5e6ac6-7e28-44ff-b599-4b096ee3745e"/>
    <ds:schemaRef ds:uri="http://purl.org/dc/terms/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0</TotalTime>
  <Words>2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-Kumar Muthappa</cp:lastModifiedBy>
  <cp:revision>43</cp:revision>
  <dcterms:created xsi:type="dcterms:W3CDTF">2015-06-03T08:23:24Z</dcterms:created>
  <dcterms:modified xsi:type="dcterms:W3CDTF">2015-08-04T11:25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